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6" r:id="rId2"/>
  </p:sldIdLst>
  <p:sldSz cx="12192000" cy="6858000"/>
  <p:notesSz cx="6858000" cy="9144000"/>
  <p:defaultTextStyle>
    <a:defPPr>
      <a:defRPr lang="en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025" autoAdjust="0"/>
    <p:restoredTop sz="94660"/>
  </p:normalViewPr>
  <p:slideViewPr>
    <p:cSldViewPr snapToGrid="0">
      <p:cViewPr varScale="1">
        <p:scale>
          <a:sx n="119" d="100"/>
          <a:sy n="119" d="100"/>
        </p:scale>
        <p:origin x="96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0B0C54-FDE8-EB11-1B1E-F9F25A0D556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9650963-A588-0091-2FBB-0D2AB747856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CFDE19-BA8D-83F3-0404-E95A0AD6EE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5B6648-6C0F-45BC-8670-F70C3A26BEF5}" type="datetimeFigureOut">
              <a:rPr lang="en-SE" smtClean="0"/>
              <a:t>2025-03-18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098E2F-6AA5-1B3E-D9B6-494F1621F7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0DEE6B-9F71-760B-E3C7-E288E09E4C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0614F-E428-45E0-94BC-D9C14677F00F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6188646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96649B-2951-5753-6C55-6DE81707C0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8CACF44-2895-1C27-0526-3884F3B6744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22ADF5-9BCD-08CB-4A6B-3D7739AC6C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5B6648-6C0F-45BC-8670-F70C3A26BEF5}" type="datetimeFigureOut">
              <a:rPr lang="en-SE" smtClean="0"/>
              <a:t>2025-03-18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503DFC-601B-90BD-A46E-AE31B03E02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23470D-027A-67E9-D3A1-E511B7A3E2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0614F-E428-45E0-94BC-D9C14677F00F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4499573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EE201DF-660E-0D13-48C1-DE15C41F62D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BFF17AA-00D9-D806-F15F-77DC1081D55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8CC073-EA09-8423-38BD-F493DD7EF0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5B6648-6C0F-45BC-8670-F70C3A26BEF5}" type="datetimeFigureOut">
              <a:rPr lang="en-SE" smtClean="0"/>
              <a:t>2025-03-18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F36A4A-6531-902E-0AA0-52CB4E9D92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8F9A51-F043-1CFF-9233-5DB71021ED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0614F-E428-45E0-94BC-D9C14677F00F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1141031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C18084-6135-4FFF-ED17-7D4EB28119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ABEB3A-4A39-69EA-7BB0-E4BAB4C9B84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13F6E5-6D78-DC9C-48E1-E3500DD410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5B6648-6C0F-45BC-8670-F70C3A26BEF5}" type="datetimeFigureOut">
              <a:rPr lang="en-SE" smtClean="0"/>
              <a:t>2025-03-18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196428-5E59-DD10-B3D7-69D0CBABA0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6044C0-ECA4-F3A9-F37E-6F01296FC2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0614F-E428-45E0-94BC-D9C14677F00F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8402512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AE986D-793C-4DBD-0147-C8418A7B42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1D4AB5F-5733-23BC-5566-CAABEC274B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40BFE2-A537-4DC3-DA35-909EF5A03A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5B6648-6C0F-45BC-8670-F70C3A26BEF5}" type="datetimeFigureOut">
              <a:rPr lang="en-SE" smtClean="0"/>
              <a:t>2025-03-18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EB2FEB-FFAB-24BC-C587-0F7FA622D0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E5422A-79FE-BFFC-1047-6AAC1A563D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0614F-E428-45E0-94BC-D9C14677F00F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42789900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F40EC7-BF2E-44F4-38C8-BD3BEE6C75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593DB25-38A9-3A2B-2BE1-55141211E12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61BCA7A-46E2-9622-EA3B-FB727EB391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1131CFC-1F2B-7611-0E93-9437419F3E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5B6648-6C0F-45BC-8670-F70C3A26BEF5}" type="datetimeFigureOut">
              <a:rPr lang="en-SE" smtClean="0"/>
              <a:t>2025-03-18</a:t>
            </a:fld>
            <a:endParaRPr lang="en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B2435C3-7C23-CC65-0D16-21FC9ADC0E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090A577-BC68-B589-CE6A-DD7FED659C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0614F-E428-45E0-94BC-D9C14677F00F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5629747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C42828-2693-D5FF-BDB6-D6ED96B5F8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A511479-3983-7FD8-09DE-CA2DE79931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BE56EB1-8E6D-C478-2DCB-E4A2C4596AD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99C0BFB-D7D0-0317-B19E-91D5737F03C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3E977E6-19DC-7D36-0B6C-13C1F4F4C0D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C21C9A8-5116-BF6E-321E-33E22D48BF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5B6648-6C0F-45BC-8670-F70C3A26BEF5}" type="datetimeFigureOut">
              <a:rPr lang="en-SE" smtClean="0"/>
              <a:t>2025-03-18</a:t>
            </a:fld>
            <a:endParaRPr lang="en-S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432DBC3-80DD-AA53-E88C-2BE3C5E6D4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C4B176B-D392-03E6-320B-1C0A8FD040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0614F-E428-45E0-94BC-D9C14677F00F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1420857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BC92B6-5F7B-AC21-F446-C58487A7C9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F115D2A-38A7-71BC-736F-6F3FB30333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5B6648-6C0F-45BC-8670-F70C3A26BEF5}" type="datetimeFigureOut">
              <a:rPr lang="en-SE" smtClean="0"/>
              <a:t>2025-03-18</a:t>
            </a:fld>
            <a:endParaRPr lang="en-S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D501DB7-EFA2-E9C5-0DE3-D1EFF6D1B4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A27E8DC-B471-FAC2-9080-376212BAEF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0614F-E428-45E0-94BC-D9C14677F00F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6485160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53E8814-02B5-4E01-437C-D46F27ECC8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5B6648-6C0F-45BC-8670-F70C3A26BEF5}" type="datetimeFigureOut">
              <a:rPr lang="en-SE" smtClean="0"/>
              <a:t>2025-03-18</a:t>
            </a:fld>
            <a:endParaRPr lang="en-S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34C4DF1-C85A-325F-9B06-56B901E7F0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01452E6-E822-615A-9174-AA2D543D58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0614F-E428-45E0-94BC-D9C14677F00F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0299022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4E1F6A-4D80-771C-52F4-BD3358DAD9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87F80F1-FA3D-5DF0-11D4-CDBA7459411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67BB202-535C-344D-FF27-AD297237561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FBF70E6-5AFE-8CC4-13A5-9835584514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5B6648-6C0F-45BC-8670-F70C3A26BEF5}" type="datetimeFigureOut">
              <a:rPr lang="en-SE" smtClean="0"/>
              <a:t>2025-03-18</a:t>
            </a:fld>
            <a:endParaRPr lang="en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40323E8-1ED9-45AE-FD2A-EBD5331F12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6F571F4-03A5-7907-9119-E4E84DA1FD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0614F-E428-45E0-94BC-D9C14677F00F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40984709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A44B88-6511-DC96-75B8-E6A1B390AB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010C671-A237-7056-8317-A3EB4B1AC64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56A39BB-75FC-CFEE-DCE8-2E8E8892F10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75D7066-9405-4FB1-F51E-3C8141ECBF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5B6648-6C0F-45BC-8670-F70C3A26BEF5}" type="datetimeFigureOut">
              <a:rPr lang="en-SE" smtClean="0"/>
              <a:t>2025-03-18</a:t>
            </a:fld>
            <a:endParaRPr lang="en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5BF78CF-8A92-746A-D7CD-4341213978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A15038-CBC4-CA04-A5B5-7BC981AB35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0614F-E428-45E0-94BC-D9C14677F00F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5449559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E664F1F-89B0-3889-431B-4F61A055B1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E506770-590E-8814-8B83-13737AD15E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95AC4A-1FDF-D818-8E13-DE06C3AAAE2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45B6648-6C0F-45BC-8670-F70C3A26BEF5}" type="datetimeFigureOut">
              <a:rPr lang="en-SE" smtClean="0"/>
              <a:t>2025-03-18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D55732-1BDB-B912-A180-9F2FA563250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7CB3BB-145E-C010-2BC4-D35D1F9FD3C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1F0614F-E428-45E0-94BC-D9C14677F00F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88315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73BC5333-B9DD-FB20-176E-9B9200A843F4}"/>
              </a:ext>
            </a:extLst>
          </p:cNvPr>
          <p:cNvSpPr txBox="1"/>
          <p:nvPr/>
        </p:nvSpPr>
        <p:spPr>
          <a:xfrm>
            <a:off x="152409" y="1"/>
            <a:ext cx="6719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sz="1200" dirty="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lang="en-S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170191F-D706-FF00-AE52-BE0876767490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t="16357" r="14337"/>
          <a:stretch/>
        </p:blipFill>
        <p:spPr>
          <a:xfrm>
            <a:off x="364396" y="368167"/>
            <a:ext cx="5891488" cy="5324247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F03DF2F9-91EA-7052-446B-ED5F8EA40D07}"/>
              </a:ext>
            </a:extLst>
          </p:cNvPr>
          <p:cNvSpPr txBox="1"/>
          <p:nvPr/>
        </p:nvSpPr>
        <p:spPr>
          <a:xfrm rot="16200000">
            <a:off x="5821790" y="2116897"/>
            <a:ext cx="11144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sz="1000" dirty="0">
                <a:latin typeface="Arial" panose="020B0604020202020204" pitchFamily="34" charset="0"/>
                <a:cs typeface="Arial" panose="020B0604020202020204" pitchFamily="34" charset="0"/>
              </a:rPr>
              <a:t>Combined score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573D5508-2761-9830-1D34-A7BE3DB5383D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85165" t="13604" r="8755" b="52638"/>
          <a:stretch/>
        </p:blipFill>
        <p:spPr>
          <a:xfrm>
            <a:off x="6446145" y="1165588"/>
            <a:ext cx="418214" cy="2148841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AC1BCCFD-EBE7-545B-1D7F-A38E046DF91B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91203" t="39342" b="47610"/>
          <a:stretch/>
        </p:blipFill>
        <p:spPr>
          <a:xfrm>
            <a:off x="6330560" y="368167"/>
            <a:ext cx="605028" cy="830591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D0107A99-B447-FAD2-03B1-923BD045ADD1}"/>
              </a:ext>
            </a:extLst>
          </p:cNvPr>
          <p:cNvSpPr txBox="1"/>
          <p:nvPr/>
        </p:nvSpPr>
        <p:spPr>
          <a:xfrm>
            <a:off x="342043" y="5609285"/>
            <a:ext cx="6989199" cy="116615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buNone/>
            </a:pP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.S2.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Yu Mincho" panose="020B0400000000000000" pitchFamily="18" charset="-128"/>
                <a:cs typeface="Arial" panose="020B0604020202020204" pitchFamily="34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 clustered heat map of the combined kinase-substrate pairs for the top </a:t>
            </a:r>
            <a:r>
              <a:rPr lang="en-US" sz="12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hosphosites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of all evaluated kinases in the placenta. A higher combined score denotes a better fit to a kinase motif and kinase-substrate phosphorylation profile of a </a:t>
            </a:r>
            <a:r>
              <a:rPr lang="en-US" sz="12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hosphosite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Most kinases belong to the CMGC and AGC kinase groups.</a:t>
            </a:r>
            <a:endParaRPr lang="en-SE" sz="12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949865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1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nisha Begum Samad</dc:creator>
  <cp:lastModifiedBy>Manisha Begum Samad</cp:lastModifiedBy>
  <cp:revision>1</cp:revision>
  <dcterms:created xsi:type="dcterms:W3CDTF">2025-03-18T09:59:39Z</dcterms:created>
  <dcterms:modified xsi:type="dcterms:W3CDTF">2025-03-18T10:00:30Z</dcterms:modified>
</cp:coreProperties>
</file>